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72B515-8502-453B-8719-D1D603837B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E0DEA4-554A-4A2A-A5B3-14CB38FFDA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4B5491-0189-436C-8859-93AC475B03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19C487-896D-4D04-B968-DC2E9778C7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283A6-7B96-464C-9848-1F409F7DBE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641EA-5E0D-4F8E-8D4B-707CEA63C3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E4222-AE33-451E-8886-CD0204B92F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40D76-C969-45AE-88F2-DF488581E1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01FA1-D14A-41D1-951A-8B344DB14D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C59F6-4C68-4F35-A548-510E666914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550EBC-D38B-4C31-BD31-D36027541D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9D422-753C-4435-9143-D47438703D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AAD644-3AC9-4836-A735-A46231E7BD1D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840FE9-9AA3-45FD-B777-375914F6ABE9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65"/>
          <p:cNvSpPr/>
          <p:nvPr/>
        </p:nvSpPr>
        <p:spPr>
          <a:xfrm>
            <a:off x="1960560" y="1512720"/>
            <a:ext cx="46292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3 </a:t>
            </a: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 Long-range PCR cycling conditions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1"/>
          <p:cNvSpPr/>
          <p:nvPr/>
        </p:nvSpPr>
        <p:spPr>
          <a:xfrm>
            <a:off x="1495440" y="239544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直线连接符 23"/>
          <p:cNvSpPr/>
          <p:nvPr/>
        </p:nvSpPr>
        <p:spPr>
          <a:xfrm>
            <a:off x="1495440" y="498636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直线连接符 24"/>
          <p:cNvSpPr/>
          <p:nvPr/>
        </p:nvSpPr>
        <p:spPr>
          <a:xfrm>
            <a:off x="1495440" y="199872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14"/>
          <p:cNvSpPr/>
          <p:nvPr/>
        </p:nvSpPr>
        <p:spPr>
          <a:xfrm>
            <a:off x="1600200" y="460836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Hold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16"/>
          <p:cNvSpPr/>
          <p:nvPr/>
        </p:nvSpPr>
        <p:spPr>
          <a:xfrm>
            <a:off x="3776760" y="243216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94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17"/>
          <p:cNvSpPr/>
          <p:nvPr/>
        </p:nvSpPr>
        <p:spPr>
          <a:xfrm>
            <a:off x="1600200" y="2430360"/>
            <a:ext cx="1754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Initial denatu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18"/>
          <p:cNvSpPr/>
          <p:nvPr/>
        </p:nvSpPr>
        <p:spPr>
          <a:xfrm>
            <a:off x="4722840" y="2443320"/>
            <a:ext cx="1204920" cy="30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04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2 mi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22"/>
          <p:cNvSpPr/>
          <p:nvPr/>
        </p:nvSpPr>
        <p:spPr>
          <a:xfrm>
            <a:off x="1600200" y="3301920"/>
            <a:ext cx="1217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Annealing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25"/>
          <p:cNvSpPr/>
          <p:nvPr/>
        </p:nvSpPr>
        <p:spPr>
          <a:xfrm>
            <a:off x="4722840" y="3271680"/>
            <a:ext cx="120492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10s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27"/>
          <p:cNvSpPr/>
          <p:nvPr/>
        </p:nvSpPr>
        <p:spPr>
          <a:xfrm>
            <a:off x="3776760" y="288432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98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28"/>
          <p:cNvSpPr/>
          <p:nvPr/>
        </p:nvSpPr>
        <p:spPr>
          <a:xfrm>
            <a:off x="3776760" y="378936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72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30"/>
          <p:cNvSpPr/>
          <p:nvPr/>
        </p:nvSpPr>
        <p:spPr>
          <a:xfrm>
            <a:off x="3776760" y="333684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65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本框 35"/>
          <p:cNvSpPr/>
          <p:nvPr/>
        </p:nvSpPr>
        <p:spPr>
          <a:xfrm>
            <a:off x="3789360" y="4657680"/>
            <a:ext cx="7192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8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本框 36"/>
          <p:cNvSpPr/>
          <p:nvPr/>
        </p:nvSpPr>
        <p:spPr>
          <a:xfrm>
            <a:off x="3776760" y="424188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72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本框 39"/>
          <p:cNvSpPr/>
          <p:nvPr/>
        </p:nvSpPr>
        <p:spPr>
          <a:xfrm>
            <a:off x="4722840" y="3733920"/>
            <a:ext cx="1204920" cy="35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3.5mi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本框 41"/>
          <p:cNvSpPr/>
          <p:nvPr/>
        </p:nvSpPr>
        <p:spPr>
          <a:xfrm>
            <a:off x="4722840" y="2858040"/>
            <a:ext cx="1204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10s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42"/>
          <p:cNvSpPr/>
          <p:nvPr/>
        </p:nvSpPr>
        <p:spPr>
          <a:xfrm>
            <a:off x="4722840" y="4199400"/>
            <a:ext cx="1204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5 mi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43"/>
          <p:cNvSpPr/>
          <p:nvPr/>
        </p:nvSpPr>
        <p:spPr>
          <a:xfrm>
            <a:off x="4722840" y="4618800"/>
            <a:ext cx="1204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∞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本框 44"/>
          <p:cNvSpPr/>
          <p:nvPr/>
        </p:nvSpPr>
        <p:spPr>
          <a:xfrm>
            <a:off x="5364000" y="423864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本框 45"/>
          <p:cNvSpPr/>
          <p:nvPr/>
        </p:nvSpPr>
        <p:spPr>
          <a:xfrm>
            <a:off x="5307120" y="4656240"/>
            <a:ext cx="2441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46"/>
          <p:cNvSpPr/>
          <p:nvPr/>
        </p:nvSpPr>
        <p:spPr>
          <a:xfrm>
            <a:off x="5365800" y="241920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本框 47"/>
          <p:cNvSpPr/>
          <p:nvPr/>
        </p:nvSpPr>
        <p:spPr>
          <a:xfrm>
            <a:off x="1865160" y="2058840"/>
            <a:ext cx="8240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Step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文本框 48"/>
          <p:cNvSpPr/>
          <p:nvPr/>
        </p:nvSpPr>
        <p:spPr>
          <a:xfrm>
            <a:off x="5035680" y="2085840"/>
            <a:ext cx="12016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Tim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文本框 49"/>
          <p:cNvSpPr/>
          <p:nvPr/>
        </p:nvSpPr>
        <p:spPr>
          <a:xfrm>
            <a:off x="6197760" y="2066760"/>
            <a:ext cx="645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Cycl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本框 50"/>
          <p:cNvSpPr/>
          <p:nvPr/>
        </p:nvSpPr>
        <p:spPr>
          <a:xfrm>
            <a:off x="3483000" y="2054160"/>
            <a:ext cx="1944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Temperatur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本框 51"/>
          <p:cNvSpPr/>
          <p:nvPr/>
        </p:nvSpPr>
        <p:spPr>
          <a:xfrm>
            <a:off x="1600200" y="2867040"/>
            <a:ext cx="1217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Denatu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本框 52"/>
          <p:cNvSpPr/>
          <p:nvPr/>
        </p:nvSpPr>
        <p:spPr>
          <a:xfrm>
            <a:off x="1600200" y="3736800"/>
            <a:ext cx="987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Extens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本框 53"/>
          <p:cNvSpPr/>
          <p:nvPr/>
        </p:nvSpPr>
        <p:spPr>
          <a:xfrm>
            <a:off x="1600200" y="4172040"/>
            <a:ext cx="134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Final extens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本框 54"/>
          <p:cNvSpPr/>
          <p:nvPr/>
        </p:nvSpPr>
        <p:spPr>
          <a:xfrm>
            <a:off x="5346720" y="331308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30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右大括号 55"/>
          <p:cNvSpPr/>
          <p:nvPr/>
        </p:nvSpPr>
        <p:spPr>
          <a:xfrm>
            <a:off x="5754600" y="2978280"/>
            <a:ext cx="324000" cy="1008000"/>
          </a:xfrm>
          <a:custGeom>
            <a:avLst/>
            <a:gdLst>
              <a:gd name="textAreaLeft" fmla="*/ 0 w 324000"/>
              <a:gd name="textAreaRight" fmla="*/ 117000 w 324000"/>
              <a:gd name="textAreaTop" fmla="*/ 8280 h 1008000"/>
              <a:gd name="textAreaBottom" fmla="*/ 999720 h 10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89"/>
                  <a:pt x="10800" y="578"/>
                </a:cubicBezTo>
                <a:lnTo>
                  <a:pt x="10800" y="10222"/>
                </a:lnTo>
                <a:cubicBezTo>
                  <a:pt x="10800" y="10511"/>
                  <a:pt x="16200" y="10800"/>
                  <a:pt x="21600" y="10800"/>
                </a:cubicBezTo>
                <a:cubicBezTo>
                  <a:pt x="16200" y="10800"/>
                  <a:pt x="10800" y="11089"/>
                  <a:pt x="10800" y="11378"/>
                </a:cubicBezTo>
                <a:lnTo>
                  <a:pt x="10800" y="21022"/>
                </a:lnTo>
                <a:cubicBezTo>
                  <a:pt x="10800" y="21311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4:27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